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83" r:id="rId3"/>
    <p:sldId id="284" r:id="rId4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815"/>
    <p:restoredTop sz="96281"/>
  </p:normalViewPr>
  <p:slideViewPr>
    <p:cSldViewPr snapToGrid="0" snapToObjects="1">
      <p:cViewPr varScale="1">
        <p:scale>
          <a:sx n="117" d="100"/>
          <a:sy n="117" d="100"/>
        </p:scale>
        <p:origin x="176" y="3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1A46BEBF-513F-A04C-A61C-B9663C82734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id="{4132F63A-887B-0346-9C9A-2BADB8F8065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mall för underrubrikforma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0742402B-662B-0344-BD31-FEAFEA7040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8A938-5772-4047-B148-B879D0DF4568}" type="datetimeFigureOut">
              <a:rPr lang="sv-SE" smtClean="0"/>
              <a:t>2022-04-22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E134485E-7DF4-EA44-B898-3D69E0F439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B72DDD83-5C38-8345-86CD-2C541096EE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5FD3F-682D-0F45-8D03-E6AD57CE57C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2378130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3FCF2B94-3E8D-5B41-A388-FCA5540D48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A5393477-375A-4E43-8773-299AB0098F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4B11B276-CEEB-814D-B6C9-7F76709937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8A938-5772-4047-B148-B879D0DF4568}" type="datetimeFigureOut">
              <a:rPr lang="sv-SE" smtClean="0"/>
              <a:t>2022-04-22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E139E011-91CB-E34F-83A5-04DA22BE36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976D3204-5D78-2643-843E-3542802128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5FD3F-682D-0F45-8D03-E6AD57CE57C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995748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>
            <a:extLst>
              <a:ext uri="{FF2B5EF4-FFF2-40B4-BE49-F238E27FC236}">
                <a16:creationId xmlns:a16="http://schemas.microsoft.com/office/drawing/2014/main" id="{C3B18246-6461-2741-8697-E61D3874E0B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0C934754-0157-E74E-93E0-62B623D97F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50173DD7-5A5F-C947-828F-2C3A2C47EE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8A938-5772-4047-B148-B879D0DF4568}" type="datetimeFigureOut">
              <a:rPr lang="sv-SE" smtClean="0"/>
              <a:t>2022-04-22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40F938BD-DD63-6A4F-ADE7-8739F20DAD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1D944F32-180C-6C40-A864-94D30320CC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5FD3F-682D-0F45-8D03-E6AD57CE57C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397933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69BB1D1B-518A-D94B-8F7C-9F0ACE3266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CC7090CD-5E4B-C540-BDD4-D010822D7EB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F2C88C55-1693-EA47-9EC1-8FE83F2339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8A938-5772-4047-B148-B879D0DF4568}" type="datetimeFigureOut">
              <a:rPr lang="sv-SE" smtClean="0"/>
              <a:t>2022-04-22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03C00672-A13F-7644-A66B-BA91CAA9DF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0E2D1149-E62D-7A48-86AF-F5D9F4AF17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5FD3F-682D-0F45-8D03-E6AD57CE57C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467879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252ADFBD-0971-BF47-B2CF-3A16A0DA43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7E208A23-4821-814B-8150-70C60D47D2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92893303-6227-C248-A8E7-9A0B7FC4DB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8A938-5772-4047-B148-B879D0DF4568}" type="datetimeFigureOut">
              <a:rPr lang="sv-SE" smtClean="0"/>
              <a:t>2022-04-22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0F1BB000-F55B-2549-A61C-862927C834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F12A61F8-79E2-2145-8942-905AABD36F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5FD3F-682D-0F45-8D03-E6AD57CE57C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632300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26BE2D66-F969-2048-BE4B-2AA4A1ECD6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66C6766C-B493-C348-958D-F487E1AD825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402ABA7F-A850-D343-ACAC-1B23180500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3AD7253D-55DF-CF4D-A89E-23AF9EDE69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8A938-5772-4047-B148-B879D0DF4568}" type="datetimeFigureOut">
              <a:rPr lang="sv-SE" smtClean="0"/>
              <a:t>2022-04-22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CB406D12-5771-2F48-A4F5-A1CB6E66E6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B525F9F2-C5D3-8945-B452-58A191EA80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5FD3F-682D-0F45-8D03-E6AD57CE57C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7119556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EF5D2290-0869-EC45-8587-F86CEEF3C6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3D607445-1578-FC48-909B-C8E034D311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FE403CC3-6EDD-9D4E-8F42-F6A739C006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>
            <a:extLst>
              <a:ext uri="{FF2B5EF4-FFF2-40B4-BE49-F238E27FC236}">
                <a16:creationId xmlns:a16="http://schemas.microsoft.com/office/drawing/2014/main" id="{CCBCB195-67CA-CC45-9B9C-82E9CF7DD29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>
            <a:extLst>
              <a:ext uri="{FF2B5EF4-FFF2-40B4-BE49-F238E27FC236}">
                <a16:creationId xmlns:a16="http://schemas.microsoft.com/office/drawing/2014/main" id="{3E4AAF99-238C-5F4D-8D81-99640AB9519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>
            <a:extLst>
              <a:ext uri="{FF2B5EF4-FFF2-40B4-BE49-F238E27FC236}">
                <a16:creationId xmlns:a16="http://schemas.microsoft.com/office/drawing/2014/main" id="{8976C461-B087-0843-803D-A90C126BE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8A938-5772-4047-B148-B879D0DF4568}" type="datetimeFigureOut">
              <a:rPr lang="sv-SE" smtClean="0"/>
              <a:t>2022-04-22</a:t>
            </a:fld>
            <a:endParaRPr lang="sv-SE"/>
          </a:p>
        </p:txBody>
      </p:sp>
      <p:sp>
        <p:nvSpPr>
          <p:cNvPr id="8" name="Platshållare för sidfot 7">
            <a:extLst>
              <a:ext uri="{FF2B5EF4-FFF2-40B4-BE49-F238E27FC236}">
                <a16:creationId xmlns:a16="http://schemas.microsoft.com/office/drawing/2014/main" id="{B6E7DC5D-E3E5-0843-9692-80C9EE2AF2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>
            <a:extLst>
              <a:ext uri="{FF2B5EF4-FFF2-40B4-BE49-F238E27FC236}">
                <a16:creationId xmlns:a16="http://schemas.microsoft.com/office/drawing/2014/main" id="{07110261-097C-7C4C-A2CE-B610771BA1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5FD3F-682D-0F45-8D03-E6AD57CE57C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486946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8660881E-225A-A34A-BA20-7A8B954875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id="{91302343-AFD1-9547-A3C5-643D02AC36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8A938-5772-4047-B148-B879D0DF4568}" type="datetimeFigureOut">
              <a:rPr lang="sv-SE" smtClean="0"/>
              <a:t>2022-04-22</a:t>
            </a:fld>
            <a:endParaRPr lang="sv-SE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id="{6AA006EE-87E9-CB41-A0CF-407B2FC74F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id="{ECC892DA-FC3A-D34A-B9A1-77F4B19C97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5FD3F-682D-0F45-8D03-E6AD57CE57C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2483295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>
            <a:extLst>
              <a:ext uri="{FF2B5EF4-FFF2-40B4-BE49-F238E27FC236}">
                <a16:creationId xmlns:a16="http://schemas.microsoft.com/office/drawing/2014/main" id="{2F8747CA-508D-FD43-AF3B-4DD9FA1294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8A938-5772-4047-B148-B879D0DF4568}" type="datetimeFigureOut">
              <a:rPr lang="sv-SE" smtClean="0"/>
              <a:t>2022-04-22</a:t>
            </a:fld>
            <a:endParaRPr lang="sv-SE"/>
          </a:p>
        </p:txBody>
      </p:sp>
      <p:sp>
        <p:nvSpPr>
          <p:cNvPr id="3" name="Platshållare för sidfot 2">
            <a:extLst>
              <a:ext uri="{FF2B5EF4-FFF2-40B4-BE49-F238E27FC236}">
                <a16:creationId xmlns:a16="http://schemas.microsoft.com/office/drawing/2014/main" id="{17870F9B-0A3B-9346-B20B-4A01EA80CE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>
            <a:extLst>
              <a:ext uri="{FF2B5EF4-FFF2-40B4-BE49-F238E27FC236}">
                <a16:creationId xmlns:a16="http://schemas.microsoft.com/office/drawing/2014/main" id="{A60F9C21-92FA-3C42-851C-B054E015D0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5FD3F-682D-0F45-8D03-E6AD57CE57C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431584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81A56647-1013-4F4B-936F-750FC0EF0F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5FF5021D-6BF1-FA46-BD94-CD76CA84856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AE8E0521-195A-E14D-8B69-0DB746928C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D708ABB0-71CC-C549-95CB-9CD2A5343E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8A938-5772-4047-B148-B879D0DF4568}" type="datetimeFigureOut">
              <a:rPr lang="sv-SE" smtClean="0"/>
              <a:t>2022-04-22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2601258C-E5CC-604A-A030-D4F292D14C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300C6A06-5B37-EF4B-B7B7-117857D184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5FD3F-682D-0F45-8D03-E6AD57CE57C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067087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78DD8A78-41CD-5345-8F13-4D6FE0467C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bild 2">
            <a:extLst>
              <a:ext uri="{FF2B5EF4-FFF2-40B4-BE49-F238E27FC236}">
                <a16:creationId xmlns:a16="http://schemas.microsoft.com/office/drawing/2014/main" id="{38DA6F06-1FA7-3C4F-AEF0-3AEF652CCD5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61507970-0394-F948-912A-83216C445A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03212956-C562-344C-86A3-0E7BC83B76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8A938-5772-4047-B148-B879D0DF4568}" type="datetimeFigureOut">
              <a:rPr lang="sv-SE" smtClean="0"/>
              <a:t>2022-04-22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D4E1B535-AA5B-2B49-86F1-5B17DC92F2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827EDC77-6BD1-0D46-A128-327C404FEB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E5FD3F-682D-0F45-8D03-E6AD57CE57C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256547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>
            <a:extLst>
              <a:ext uri="{FF2B5EF4-FFF2-40B4-BE49-F238E27FC236}">
                <a16:creationId xmlns:a16="http://schemas.microsoft.com/office/drawing/2014/main" id="{35A8E72B-2952-E14C-8C6E-19A9F6D0A4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AEBF24D9-592B-4E4C-B81A-879D4F33B8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8C9AF640-ED44-1941-B908-08E143EBE42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78A938-5772-4047-B148-B879D0DF4568}" type="datetimeFigureOut">
              <a:rPr lang="sv-SE" smtClean="0"/>
              <a:t>2022-04-22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B404AD2E-F80E-7F4B-A136-382A7FC196F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F96D5E01-ED84-4644-83DD-B68AC7014C8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E5FD3F-682D-0F45-8D03-E6AD57CE57C5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069385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l 5">
            <a:extLst>
              <a:ext uri="{FF2B5EF4-FFF2-40B4-BE49-F238E27FC236}">
                <a16:creationId xmlns:a16="http://schemas.microsoft.com/office/drawing/2014/main" id="{49353029-D059-5E4E-ABA1-FFEE1F27850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75305419"/>
              </p:ext>
            </p:extLst>
          </p:nvPr>
        </p:nvGraphicFramePr>
        <p:xfrm>
          <a:off x="495132" y="283720"/>
          <a:ext cx="11090987" cy="72576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04039">
                  <a:extLst>
                    <a:ext uri="{9D8B030D-6E8A-4147-A177-3AD203B41FA5}">
                      <a16:colId xmlns:a16="http://schemas.microsoft.com/office/drawing/2014/main" val="292886741"/>
                    </a:ext>
                  </a:extLst>
                </a:gridCol>
                <a:gridCol w="533333">
                  <a:extLst>
                    <a:ext uri="{9D8B030D-6E8A-4147-A177-3AD203B41FA5}">
                      <a16:colId xmlns:a16="http://schemas.microsoft.com/office/drawing/2014/main" val="2453945859"/>
                    </a:ext>
                  </a:extLst>
                </a:gridCol>
                <a:gridCol w="776811">
                  <a:extLst>
                    <a:ext uri="{9D8B030D-6E8A-4147-A177-3AD203B41FA5}">
                      <a16:colId xmlns:a16="http://schemas.microsoft.com/office/drawing/2014/main" val="3146711448"/>
                    </a:ext>
                  </a:extLst>
                </a:gridCol>
                <a:gridCol w="1008695">
                  <a:extLst>
                    <a:ext uri="{9D8B030D-6E8A-4147-A177-3AD203B41FA5}">
                      <a16:colId xmlns:a16="http://schemas.microsoft.com/office/drawing/2014/main" val="4078493698"/>
                    </a:ext>
                  </a:extLst>
                </a:gridCol>
                <a:gridCol w="1704346">
                  <a:extLst>
                    <a:ext uri="{9D8B030D-6E8A-4147-A177-3AD203B41FA5}">
                      <a16:colId xmlns:a16="http://schemas.microsoft.com/office/drawing/2014/main" val="2578480405"/>
                    </a:ext>
                  </a:extLst>
                </a:gridCol>
                <a:gridCol w="2193710">
                  <a:extLst>
                    <a:ext uri="{9D8B030D-6E8A-4147-A177-3AD203B41FA5}">
                      <a16:colId xmlns:a16="http://schemas.microsoft.com/office/drawing/2014/main" val="1440950164"/>
                    </a:ext>
                  </a:extLst>
                </a:gridCol>
                <a:gridCol w="1136895">
                  <a:extLst>
                    <a:ext uri="{9D8B030D-6E8A-4147-A177-3AD203B41FA5}">
                      <a16:colId xmlns:a16="http://schemas.microsoft.com/office/drawing/2014/main" val="1655146180"/>
                    </a:ext>
                  </a:extLst>
                </a:gridCol>
                <a:gridCol w="1504173">
                  <a:extLst>
                    <a:ext uri="{9D8B030D-6E8A-4147-A177-3AD203B41FA5}">
                      <a16:colId xmlns:a16="http://schemas.microsoft.com/office/drawing/2014/main" val="3188192603"/>
                    </a:ext>
                  </a:extLst>
                </a:gridCol>
                <a:gridCol w="1228985">
                  <a:extLst>
                    <a:ext uri="{9D8B030D-6E8A-4147-A177-3AD203B41FA5}">
                      <a16:colId xmlns:a16="http://schemas.microsoft.com/office/drawing/2014/main" val="2556088046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algn="l"/>
                      <a:r>
                        <a:rPr lang="sv-SE" sz="9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pplementary</a:t>
                      </a:r>
                      <a:r>
                        <a:rPr lang="sv-SE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able S1. </a:t>
                      </a:r>
                      <a:r>
                        <a:rPr lang="sv-SE" sz="9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mographic</a:t>
                      </a:r>
                      <a:r>
                        <a:rPr lang="sv-SE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sv-SE" sz="9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aracteristics</a:t>
                      </a:r>
                      <a:r>
                        <a:rPr lang="sv-SE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sv-SE" sz="9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f</a:t>
                      </a:r>
                      <a:r>
                        <a:rPr lang="sv-SE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sv-SE" sz="9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luded</a:t>
                      </a:r>
                      <a:r>
                        <a:rPr lang="sv-SE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tudies.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9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9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7697620"/>
                  </a:ext>
                </a:extLst>
              </a:tr>
              <a:tr h="370840">
                <a:tc gridSpan="7">
                  <a:txBody>
                    <a:bodyPr/>
                    <a:lstStyle/>
                    <a:p>
                      <a:pPr algn="l"/>
                      <a:r>
                        <a:rPr lang="en-US" sz="900" b="1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dependent samples</a:t>
                      </a:r>
                    </a:p>
                  </a:txBody>
                  <a:tcPr marL="64800" marR="6480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en-US" sz="9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9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9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9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9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900" b="1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900" b="1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65481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dy no.; Author (Year);</a:t>
                      </a:r>
                    </a:p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untry</a:t>
                      </a:r>
                    </a:p>
                  </a:txBody>
                  <a:tcPr marL="64800" marR="64800" marB="81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 size</a:t>
                      </a:r>
                    </a:p>
                  </a:txBody>
                  <a:tcPr marL="64800" marR="64800" marB="81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der</a:t>
                      </a:r>
                    </a:p>
                  </a:txBody>
                  <a:tcPr marL="64800" marR="64800" marB="81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</a:p>
                  </a:txBody>
                  <a:tcPr marL="64800" marR="64800" marB="81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i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hnicity</a:t>
                      </a:r>
                    </a:p>
                  </a:txBody>
                  <a:tcPr marL="64800" marR="64800" marB="81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cio-Economic Status</a:t>
                      </a:r>
                    </a:p>
                  </a:txBody>
                  <a:tcPr marL="64800" marR="64800" marB="81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-occurring physical/sensory disabilities</a:t>
                      </a:r>
                    </a:p>
                  </a:txBody>
                  <a:tcPr marL="64800" marR="64800" marB="81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 co-occurring conditions</a:t>
                      </a:r>
                    </a:p>
                  </a:txBody>
                  <a:tcPr marL="64800" marR="64800" marB="81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cial isolation; lone parenting</a:t>
                      </a:r>
                    </a:p>
                  </a:txBody>
                  <a:tcPr marL="64800" marR="64800" marB="81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3025595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; </a:t>
                      </a:r>
                      <a:r>
                        <a:rPr lang="en-US" sz="900" noProof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llberg</a:t>
                      </a: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&amp; </a:t>
                      </a:r>
                      <a:r>
                        <a:rPr lang="en-US" sz="900" noProof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ijer</a:t>
                      </a: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Karlsson (1983)</a:t>
                      </a:r>
                    </a:p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weden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15</a:t>
                      </a:r>
                      <a:endParaRPr lang="en-US" sz="900" i="1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% female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-39 years (</a:t>
                      </a:r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34.0, </a:t>
                      </a:r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D =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)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% lived under “unsatisfactory” psychosocial conditions. 62% received support from social services </a:t>
                      </a:r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 =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)</a:t>
                      </a:r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% had “alcohol problems”.</a:t>
                      </a:r>
                    </a:p>
                    <a:p>
                      <a:pPr algn="l"/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 (but 92% were unmarried; </a:t>
                      </a:r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13).</a:t>
                      </a:r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958237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; Seagull &amp; </a:t>
                      </a:r>
                      <a:r>
                        <a:rPr lang="en-US" sz="900" noProof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heurer</a:t>
                      </a: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1986)</a:t>
                      </a:r>
                    </a:p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ited States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27</a:t>
                      </a:r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4% female;</a:t>
                      </a:r>
                    </a:p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% male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% of female participants were White. Ethnicity of male participants not clearly reported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t explicitly stated, but 100% of parents received publicly financed support, and a mean of 10 additional community services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4500948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; </a:t>
                      </a:r>
                      <a:r>
                        <a:rPr lang="en-US" sz="900" noProof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ymchuk</a:t>
                      </a: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&amp; </a:t>
                      </a:r>
                      <a:r>
                        <a:rPr lang="en-US" sz="900" noProof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dron</a:t>
                      </a: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1990)</a:t>
                      </a:r>
                    </a:p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ited States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33</a:t>
                      </a:r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% female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% Black, Hispanic, or Native American; 45% White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% had a yearly income &lt; $10,000. 70% received financial support. 45% had not entered Senior High School. 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 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% had “problems in addition to ID”, but specific data regarding these problems are not clearly reported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 (but 52% were unmarried)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9688637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4; </a:t>
                      </a:r>
                      <a:r>
                        <a:rPr lang="en-US" sz="900" noProof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aun</a:t>
                      </a: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&amp; Brown (1999)</a:t>
                      </a:r>
                    </a:p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ustrali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12</a:t>
                      </a:r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% female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-40 years (</a:t>
                      </a:r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26).</a:t>
                      </a:r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2% Caucasian; 8% Maori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3% were “totally dependent on welfare for financial survival”; 25% had no fixed address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% of participants had a sensory impairment in addition to their ID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% had a psychiatric condition.</a:t>
                      </a:r>
                    </a:p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%  had substance abuse. 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63692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; Ehlers-Flint (2002)</a:t>
                      </a:r>
                    </a:p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ited States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20</a:t>
                      </a:r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% female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-43 years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% African-American, 35% Caucasian; 15% Hispanic; 5% Asian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“Most mothers” had disability benefits as their main source of income. 50% had a yearly household income ≤ $12,000. 80% had a high school diploma. 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% lived without a partner in the household; 30% lived without no other adults in the household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81594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; Llewellyn et al. (2003)</a:t>
                      </a:r>
                    </a:p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ustrali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50</a:t>
                      </a:r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% female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-47 years </a:t>
                      </a:r>
                    </a:p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31.1)</a:t>
                      </a:r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4% of mothers had welfare as their sole source of income. 66% lived in public housing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% lived without a partner in the household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227274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; Elvish et al. (2006)</a:t>
                      </a:r>
                    </a:p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ited Kingdom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82</a:t>
                      </a:r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28177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; McGaw et al. (2010)</a:t>
                      </a:r>
                    </a:p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ited Kingdom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101</a:t>
                      </a:r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% female; 4% male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-risk: 18-55 years, </a:t>
                      </a:r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30.4;</a:t>
                      </a:r>
                    </a:p>
                    <a:p>
                      <a:pPr algn="l"/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 risk: 17-44 years, </a:t>
                      </a:r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29.8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% of parents had a physical disability in addition to their ID (18.3% of  high-risk parents; 4.9% of low-risk parents; difference significant at </a:t>
                      </a:r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.04</a:t>
                      </a: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. 5% had a sensory impairment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% had mental health problems (48.3 of high-risk mothers; 34.1% of low-risk mothers; difference not significant)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% were single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8194886"/>
                  </a:ext>
                </a:extLst>
              </a:tr>
              <a:tr h="370840">
                <a:tc gridSpan="9"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i="1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continued)</a:t>
                      </a:r>
                    </a:p>
                    <a:p>
                      <a:pPr algn="r"/>
                      <a:endParaRPr lang="en-US" sz="900" i="1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720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/>
                      <a:endParaRPr lang="en-US" sz="9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720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/>
                      <a:endParaRPr lang="en-US" sz="9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720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/>
                      <a:endParaRPr lang="en-US" sz="9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720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/>
                      <a:endParaRPr lang="en-US" sz="9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720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/>
                      <a:endParaRPr lang="en-US" sz="9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720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r"/>
                      <a:endParaRPr lang="en-US" sz="900" i="1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720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r"/>
                      <a:endParaRPr lang="en-US" sz="900" i="1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720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049200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731126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l 5">
            <a:extLst>
              <a:ext uri="{FF2B5EF4-FFF2-40B4-BE49-F238E27FC236}">
                <a16:creationId xmlns:a16="http://schemas.microsoft.com/office/drawing/2014/main" id="{49353029-D059-5E4E-ABA1-FFEE1F27850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70552238"/>
              </p:ext>
            </p:extLst>
          </p:nvPr>
        </p:nvGraphicFramePr>
        <p:xfrm>
          <a:off x="495132" y="283720"/>
          <a:ext cx="11090987" cy="66445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04039">
                  <a:extLst>
                    <a:ext uri="{9D8B030D-6E8A-4147-A177-3AD203B41FA5}">
                      <a16:colId xmlns:a16="http://schemas.microsoft.com/office/drawing/2014/main" val="292886741"/>
                    </a:ext>
                  </a:extLst>
                </a:gridCol>
                <a:gridCol w="533333">
                  <a:extLst>
                    <a:ext uri="{9D8B030D-6E8A-4147-A177-3AD203B41FA5}">
                      <a16:colId xmlns:a16="http://schemas.microsoft.com/office/drawing/2014/main" val="2453945859"/>
                    </a:ext>
                  </a:extLst>
                </a:gridCol>
                <a:gridCol w="776811">
                  <a:extLst>
                    <a:ext uri="{9D8B030D-6E8A-4147-A177-3AD203B41FA5}">
                      <a16:colId xmlns:a16="http://schemas.microsoft.com/office/drawing/2014/main" val="3146711448"/>
                    </a:ext>
                  </a:extLst>
                </a:gridCol>
                <a:gridCol w="1008695">
                  <a:extLst>
                    <a:ext uri="{9D8B030D-6E8A-4147-A177-3AD203B41FA5}">
                      <a16:colId xmlns:a16="http://schemas.microsoft.com/office/drawing/2014/main" val="4078493698"/>
                    </a:ext>
                  </a:extLst>
                </a:gridCol>
                <a:gridCol w="1704346">
                  <a:extLst>
                    <a:ext uri="{9D8B030D-6E8A-4147-A177-3AD203B41FA5}">
                      <a16:colId xmlns:a16="http://schemas.microsoft.com/office/drawing/2014/main" val="2578480405"/>
                    </a:ext>
                  </a:extLst>
                </a:gridCol>
                <a:gridCol w="2193710">
                  <a:extLst>
                    <a:ext uri="{9D8B030D-6E8A-4147-A177-3AD203B41FA5}">
                      <a16:colId xmlns:a16="http://schemas.microsoft.com/office/drawing/2014/main" val="1440950164"/>
                    </a:ext>
                  </a:extLst>
                </a:gridCol>
                <a:gridCol w="1136895">
                  <a:extLst>
                    <a:ext uri="{9D8B030D-6E8A-4147-A177-3AD203B41FA5}">
                      <a16:colId xmlns:a16="http://schemas.microsoft.com/office/drawing/2014/main" val="1655146180"/>
                    </a:ext>
                  </a:extLst>
                </a:gridCol>
                <a:gridCol w="1504173">
                  <a:extLst>
                    <a:ext uri="{9D8B030D-6E8A-4147-A177-3AD203B41FA5}">
                      <a16:colId xmlns:a16="http://schemas.microsoft.com/office/drawing/2014/main" val="3188192603"/>
                    </a:ext>
                  </a:extLst>
                </a:gridCol>
                <a:gridCol w="1228985">
                  <a:extLst>
                    <a:ext uri="{9D8B030D-6E8A-4147-A177-3AD203B41FA5}">
                      <a16:colId xmlns:a16="http://schemas.microsoft.com/office/drawing/2014/main" val="2556088046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algn="l"/>
                      <a:r>
                        <a:rPr lang="sv-SE" sz="9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pplementary</a:t>
                      </a:r>
                      <a:r>
                        <a:rPr lang="sv-SE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able S1 </a:t>
                      </a:r>
                      <a:r>
                        <a:rPr lang="sv-SE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sv-SE" sz="9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inued</a:t>
                      </a:r>
                      <a:r>
                        <a:rPr lang="sv-SE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.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9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9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7697620"/>
                  </a:ext>
                </a:extLst>
              </a:tr>
              <a:tr h="370840">
                <a:tc gridSpan="7">
                  <a:txBody>
                    <a:bodyPr/>
                    <a:lstStyle/>
                    <a:p>
                      <a:pPr algn="l"/>
                      <a:r>
                        <a:rPr lang="en-US" sz="900" b="1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dependent samples</a:t>
                      </a:r>
                    </a:p>
                  </a:txBody>
                  <a:tcPr marL="64800" marR="6480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en-US" sz="9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9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9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9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9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900" b="1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900" b="1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65481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dy no.; Author (Year);</a:t>
                      </a:r>
                    </a:p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untry</a:t>
                      </a:r>
                    </a:p>
                  </a:txBody>
                  <a:tcPr marL="64800" marR="64800" marB="81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 size</a:t>
                      </a:r>
                    </a:p>
                  </a:txBody>
                  <a:tcPr marL="64800" marR="64800" marB="81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der</a:t>
                      </a:r>
                    </a:p>
                  </a:txBody>
                  <a:tcPr marL="64800" marR="64800" marB="81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</a:p>
                  </a:txBody>
                  <a:tcPr marL="64800" marR="64800" marB="81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i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hnicity</a:t>
                      </a:r>
                    </a:p>
                  </a:txBody>
                  <a:tcPr marL="64800" marR="64800" marB="81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cio-Economic Status</a:t>
                      </a:r>
                    </a:p>
                  </a:txBody>
                  <a:tcPr marL="64800" marR="64800" marB="81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-occurring physical/sensory disabilities</a:t>
                      </a:r>
                    </a:p>
                  </a:txBody>
                  <a:tcPr marL="64800" marR="64800" marB="81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 co-occurring conditions</a:t>
                      </a:r>
                    </a:p>
                  </a:txBody>
                  <a:tcPr marL="64800" marR="64800" marB="81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cial isolation; lone parenting</a:t>
                      </a:r>
                    </a:p>
                  </a:txBody>
                  <a:tcPr marL="64800" marR="64800" marB="81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3025595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; McConnell et al. (2011)</a:t>
                      </a:r>
                    </a:p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nad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1170</a:t>
                      </a:r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 (but at least 72.1% female)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3.2% Non-Aboriginal; 26.8% Aboriginal status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9.1% had a yearly household income &lt; $25,000; 49.6% reported no household employment; 68.6% had not finished secondary school; 27.3% lived in public housing or shelter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.6% had mental health issues in addition to their ID; 51.5% had drug or alcohol abuse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.2% had few social supports; 47% were lone parents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4500948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; Emerson &amp; Brigham (2013)</a:t>
                      </a:r>
                    </a:p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ited Kingdom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168</a:t>
                      </a:r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4% had low income and were dependent on welfare benefits; 71% were unemployed; 36% lived in poor housing. 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% had mental health issues in addition to their ID; 14% had alcohol abuse; 15% had drug abuse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% lived without a partner in the household; 34% lived in social isolation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9688637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 Granqvist et al., (2014)</a:t>
                      </a:r>
                    </a:p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weden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23</a:t>
                      </a:r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% female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-44 years (</a:t>
                      </a:r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34.2, SD = 5.9).</a:t>
                      </a:r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thers had a mean yearly income of  SEK 139,920 (≈ $15,000)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% lived without a partner in the household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63692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; </a:t>
                      </a:r>
                      <a:r>
                        <a:rPr lang="en-US" sz="900" noProof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llfritz</a:t>
                      </a: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2018)</a:t>
                      </a:r>
                    </a:p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rmany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127</a:t>
                      </a:r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.6% female; 2.4% male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-54 years (</a:t>
                      </a:r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 =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.5)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4.3% had not completed secondary school. 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% had a physical disability in addition to their ID; 7.1% had hearing loss; 2.4% had visual impairment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1% had a psychiatric condition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.1% lived without a partner in the household; 2.4% lived in social isolation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81594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; Pacheco et al (2021); Canad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1244</a:t>
                      </a:r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.3% female; 8.7% male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.6% Non-Aboriginal; 29.4% Aboriginal status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.8% lived in financial hardship; 60.2% received social assistance; 30.1% lived in public housing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.5% reported physical health problems, defined as chronic illness, frequent hospitalizations, or physical disability. The nature of the problems is not further specified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% of caregivers reported mental health problems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6.3% had few social supports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682164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 McConnell et al. (2021a)</a:t>
                      </a:r>
                    </a:p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nad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91</a:t>
                      </a:r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% female; 10% male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38.9 years; </a:t>
                      </a:r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D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10.7</a:t>
                      </a:r>
                      <a:endParaRPr lang="en-US" sz="900" i="1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.2% had a yearly household income &lt; $24,000; 70.3% had not completed secondary school; 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t explicitly stated, but 11% received disability support due to physical or sensory impairment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.6% lived without a partner; 37.5% lived without other adults in the household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37290069"/>
                  </a:ext>
                </a:extLst>
              </a:tr>
              <a:tr h="370840">
                <a:tc gridSpan="9"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i="1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continued)</a:t>
                      </a:r>
                    </a:p>
                    <a:p>
                      <a:pPr algn="r"/>
                      <a:endParaRPr lang="en-US" sz="900" i="1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720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/>
                      <a:endParaRPr lang="en-US" sz="9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720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/>
                      <a:endParaRPr lang="en-US" sz="9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720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/>
                      <a:endParaRPr lang="en-US" sz="9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720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/>
                      <a:endParaRPr lang="en-US" sz="9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720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/>
                      <a:endParaRPr lang="en-US" sz="9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720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r"/>
                      <a:endParaRPr lang="en-US" sz="900" i="1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720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r"/>
                      <a:endParaRPr lang="en-US" sz="900" i="1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2000" marR="720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049200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416605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l 5">
            <a:extLst>
              <a:ext uri="{FF2B5EF4-FFF2-40B4-BE49-F238E27FC236}">
                <a16:creationId xmlns:a16="http://schemas.microsoft.com/office/drawing/2014/main" id="{49353029-D059-5E4E-ABA1-FFEE1F27850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52242842"/>
              </p:ext>
            </p:extLst>
          </p:nvPr>
        </p:nvGraphicFramePr>
        <p:xfrm>
          <a:off x="495132" y="283720"/>
          <a:ext cx="11090987" cy="69188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04039">
                  <a:extLst>
                    <a:ext uri="{9D8B030D-6E8A-4147-A177-3AD203B41FA5}">
                      <a16:colId xmlns:a16="http://schemas.microsoft.com/office/drawing/2014/main" val="292886741"/>
                    </a:ext>
                  </a:extLst>
                </a:gridCol>
                <a:gridCol w="533333">
                  <a:extLst>
                    <a:ext uri="{9D8B030D-6E8A-4147-A177-3AD203B41FA5}">
                      <a16:colId xmlns:a16="http://schemas.microsoft.com/office/drawing/2014/main" val="2453945859"/>
                    </a:ext>
                  </a:extLst>
                </a:gridCol>
                <a:gridCol w="776811">
                  <a:extLst>
                    <a:ext uri="{9D8B030D-6E8A-4147-A177-3AD203B41FA5}">
                      <a16:colId xmlns:a16="http://schemas.microsoft.com/office/drawing/2014/main" val="3146711448"/>
                    </a:ext>
                  </a:extLst>
                </a:gridCol>
                <a:gridCol w="1008695">
                  <a:extLst>
                    <a:ext uri="{9D8B030D-6E8A-4147-A177-3AD203B41FA5}">
                      <a16:colId xmlns:a16="http://schemas.microsoft.com/office/drawing/2014/main" val="4078493698"/>
                    </a:ext>
                  </a:extLst>
                </a:gridCol>
                <a:gridCol w="1704346">
                  <a:extLst>
                    <a:ext uri="{9D8B030D-6E8A-4147-A177-3AD203B41FA5}">
                      <a16:colId xmlns:a16="http://schemas.microsoft.com/office/drawing/2014/main" val="2578480405"/>
                    </a:ext>
                  </a:extLst>
                </a:gridCol>
                <a:gridCol w="2193710">
                  <a:extLst>
                    <a:ext uri="{9D8B030D-6E8A-4147-A177-3AD203B41FA5}">
                      <a16:colId xmlns:a16="http://schemas.microsoft.com/office/drawing/2014/main" val="1440950164"/>
                    </a:ext>
                  </a:extLst>
                </a:gridCol>
                <a:gridCol w="1136895">
                  <a:extLst>
                    <a:ext uri="{9D8B030D-6E8A-4147-A177-3AD203B41FA5}">
                      <a16:colId xmlns:a16="http://schemas.microsoft.com/office/drawing/2014/main" val="1655146180"/>
                    </a:ext>
                  </a:extLst>
                </a:gridCol>
                <a:gridCol w="1504173">
                  <a:extLst>
                    <a:ext uri="{9D8B030D-6E8A-4147-A177-3AD203B41FA5}">
                      <a16:colId xmlns:a16="http://schemas.microsoft.com/office/drawing/2014/main" val="3188192603"/>
                    </a:ext>
                  </a:extLst>
                </a:gridCol>
                <a:gridCol w="1228985">
                  <a:extLst>
                    <a:ext uri="{9D8B030D-6E8A-4147-A177-3AD203B41FA5}">
                      <a16:colId xmlns:a16="http://schemas.microsoft.com/office/drawing/2014/main" val="2556088046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algn="l"/>
                      <a:r>
                        <a:rPr lang="sv-SE" sz="9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pplementary</a:t>
                      </a:r>
                      <a:r>
                        <a:rPr lang="sv-SE" sz="9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able S1 </a:t>
                      </a:r>
                      <a:r>
                        <a:rPr lang="sv-SE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sv-SE" sz="9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inued</a:t>
                      </a:r>
                      <a:r>
                        <a:rPr lang="sv-SE" sz="9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.</a:t>
                      </a: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sv-SE" sz="9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9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sv-SE" sz="9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7697620"/>
                  </a:ext>
                </a:extLst>
              </a:tr>
              <a:tr h="370840">
                <a:tc gridSpan="7">
                  <a:txBody>
                    <a:bodyPr/>
                    <a:lstStyle/>
                    <a:p>
                      <a:pPr algn="l"/>
                      <a:r>
                        <a:rPr lang="en-US" sz="900" b="1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verlapping samples</a:t>
                      </a:r>
                    </a:p>
                  </a:txBody>
                  <a:tcPr marL="64800" marR="6480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sv-S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en-US" sz="9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9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9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9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900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900" b="1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900" b="1" noProof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65481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dy no.; Author (Year);</a:t>
                      </a:r>
                    </a:p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untry</a:t>
                      </a:r>
                    </a:p>
                  </a:txBody>
                  <a:tcPr marL="64800" marR="64800" marB="81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 size</a:t>
                      </a:r>
                    </a:p>
                  </a:txBody>
                  <a:tcPr marL="64800" marR="64800" marB="81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der</a:t>
                      </a:r>
                    </a:p>
                  </a:txBody>
                  <a:tcPr marL="64800" marR="64800" marB="81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</a:p>
                  </a:txBody>
                  <a:tcPr marL="64800" marR="64800" marB="81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i="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hnicity</a:t>
                      </a:r>
                    </a:p>
                  </a:txBody>
                  <a:tcPr marL="64800" marR="64800" marB="81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cio-Economic Status</a:t>
                      </a:r>
                    </a:p>
                  </a:txBody>
                  <a:tcPr marL="64800" marR="64800" marB="81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-occurring physical/sensory disabilities</a:t>
                      </a:r>
                    </a:p>
                  </a:txBody>
                  <a:tcPr marL="64800" marR="64800" marB="81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 co-occurring conditions</a:t>
                      </a:r>
                    </a:p>
                  </a:txBody>
                  <a:tcPr marL="64800" marR="64800" marB="81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cial isolation; partner status</a:t>
                      </a:r>
                    </a:p>
                  </a:txBody>
                  <a:tcPr marL="64800" marR="64800" marB="8172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3025595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b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; McConnell et al. (2003)</a:t>
                      </a:r>
                    </a:p>
                    <a:p>
                      <a:pPr algn="l"/>
                      <a:r>
                        <a:rPr lang="en-US" sz="900" b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ustralia</a:t>
                      </a:r>
                    </a:p>
                    <a:p>
                      <a:pPr algn="l"/>
                      <a:r>
                        <a:rPr lang="en-US" sz="900" b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sample overlap with no. 6)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40</a:t>
                      </a:r>
                      <a:endParaRPr lang="en-US" sz="900" b="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% female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-45 years (</a:t>
                      </a:r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31.4; </a:t>
                      </a:r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D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5.8).</a:t>
                      </a:r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% White; 3% Aboriginal Australian (</a:t>
                      </a:r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37).</a:t>
                      </a:r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% relied on disability pensions and governmental allowances for income; 76% lived in public housing; 24% had not completed Junior High School; 89% had not completed Senior High School. 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% lived without a partner in the household (</a:t>
                      </a:r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37).</a:t>
                      </a:r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63692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; McGaw et al., (2007) United Kingdom</a:t>
                      </a:r>
                    </a:p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sample overlap with no. 8) 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49</a:t>
                      </a:r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.1% female; 30.9% male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-54 years (</a:t>
                      </a:r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 =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2, </a:t>
                      </a:r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D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6.98)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v-SE" sz="9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0% </a:t>
                      </a:r>
                      <a:r>
                        <a:rPr lang="sv-SE" sz="900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ad</a:t>
                      </a:r>
                      <a:r>
                        <a:rPr lang="sv-SE" sz="9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sv-SE" sz="900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ow</a:t>
                      </a:r>
                      <a:r>
                        <a:rPr lang="sv-SE" sz="9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SES and </a:t>
                      </a:r>
                      <a:r>
                        <a:rPr lang="sv-SE" sz="900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eceived</a:t>
                      </a:r>
                      <a:r>
                        <a:rPr lang="sv-SE" sz="9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sv-SE" sz="900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tatutory</a:t>
                      </a:r>
                      <a:r>
                        <a:rPr lang="sv-SE" sz="9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sv-SE" sz="900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ncome</a:t>
                      </a:r>
                      <a:r>
                        <a:rPr lang="sv-SE" sz="9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support. </a:t>
                      </a:r>
                      <a:endParaRPr lang="sv-SE" sz="9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% demonstrated some form of psychopathology. 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% were lone parents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881594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; Feldman et al. (2012)</a:t>
                      </a:r>
                    </a:p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nada</a:t>
                      </a:r>
                    </a:p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same sample as no. 9)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1170</a:t>
                      </a:r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 (but at least 72.1% female)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3.2% Non-Aboriginal; 26.8% Aboriginal status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9.1% had a yearly household income &lt; $25,000; 49.6% reported no household employment; 68.6% had not completed secondary school; 27.3% lived in public housing or shelter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 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.6% had mental health issues in addition to their ID; 51.5% had drug or alcohol abuse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.2% had few social supports; 47% were lone parents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543244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b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; Lindberg et al. (2017)</a:t>
                      </a:r>
                    </a:p>
                    <a:p>
                      <a:pPr algn="l"/>
                      <a:r>
                        <a:rPr lang="en-US" sz="900" b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weden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same sample as no. 11)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23</a:t>
                      </a:r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% female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-44 years (</a:t>
                      </a:r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34.2, SD = 5.9).</a:t>
                      </a:r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thers had a mean yearly income of  SEK 139,920 (≈ $15,000)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% lived without a partner in the household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313084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; McConnell et al. (2021b)</a:t>
                      </a:r>
                    </a:p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nada</a:t>
                      </a:r>
                    </a:p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sample overlap with no. 13)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1000</a:t>
                      </a:r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.6% female; 8.4% male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.9% Non-Aboriginal; 34.1% Aboriginal status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.6% lived in financial hardship; 62.6% received social assistance; 30.9% lived in public housing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9% reported physical health problems, defined as chronic illness, frequent hospitalizations, or physical disability. The nature of the problems is not further specified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.8% had mental health issues in addition to their ID; 43.4% had substance abuse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.3% were sole-parents; 64.6% lived in social isolation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341587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; Hammarlund et al., (2021)</a:t>
                      </a:r>
                    </a:p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weden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same sample as no. 11)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23</a:t>
                      </a:r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% female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-44 years (</a:t>
                      </a:r>
                      <a:r>
                        <a:rPr lang="en-US" sz="900" i="1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 </a:t>
                      </a: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34.2, SD = 5.9).</a:t>
                      </a:r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thers had a mean yearly income of  SEK 139,920 (≈ $15,000)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% lived without a partner in the household.</a:t>
                      </a: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0492005"/>
                  </a:ext>
                </a:extLst>
              </a:tr>
              <a:tr h="370840">
                <a:tc gridSpan="9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i="0" noProof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te: ID = Intellectual Disability; NA = Not Available; SEK = Swedish kronor; SES = Socio-Economic Status.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/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/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/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/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/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/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noProof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800" marR="64800" marT="46800" marB="540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905384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804168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092</TotalTime>
  <Words>1736</Words>
  <Application>Microsoft Macintosh PowerPoint</Application>
  <PresentationFormat>Bredbild</PresentationFormat>
  <Paragraphs>246</Paragraphs>
  <Slides>3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4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-tema</vt:lpstr>
      <vt:lpstr>PowerPoint-presentation</vt:lpstr>
      <vt:lpstr>PowerPoint-presentation</vt:lpstr>
      <vt:lpstr>PowerPoint-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Mårten Hammarlund</dc:creator>
  <cp:lastModifiedBy>Mårten Hammarlund</cp:lastModifiedBy>
  <cp:revision>22</cp:revision>
  <dcterms:created xsi:type="dcterms:W3CDTF">2022-03-31T19:08:38Z</dcterms:created>
  <dcterms:modified xsi:type="dcterms:W3CDTF">2022-04-22T22:07:03Z</dcterms:modified>
</cp:coreProperties>
</file>